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1" r:id="rId2"/>
    <p:sldId id="258" r:id="rId3"/>
    <p:sldId id="259" r:id="rId4"/>
    <p:sldId id="263" r:id="rId5"/>
    <p:sldId id="265" r:id="rId6"/>
    <p:sldId id="266" r:id="rId7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C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486" autoAdjust="0"/>
    <p:restoredTop sz="94470" autoAdjust="0"/>
  </p:normalViewPr>
  <p:slideViewPr>
    <p:cSldViewPr snapToGrid="0">
      <p:cViewPr varScale="1">
        <p:scale>
          <a:sx n="123" d="100"/>
          <a:sy n="123" d="100"/>
        </p:scale>
        <p:origin x="-2744" y="-112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notesMaster" Target="notesMasters/notesMaster1.xml"/><Relationship Id="rId9" Type="http://schemas.openxmlformats.org/officeDocument/2006/relationships/printerSettings" Target="printerSettings/printerSettings1.bin"/><Relationship Id="rId10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7CF048-0FAE-4ADD-951E-4E58407CC223}" type="datetimeFigureOut">
              <a:rPr lang="ko-KR" altLang="en-US" smtClean="0"/>
              <a:t>3/27/18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5D99557-6774-4A23-B909-E0FC0A0ABB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636355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5D99557-6774-4A23-B909-E0FC0A0ABB45}" type="slidenum">
              <a:rPr lang="ko-KR" altLang="en-US" smtClean="0"/>
              <a:t>5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481285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72B03-8135-44CE-88F9-2CB997127D73}" type="datetimeFigureOut">
              <a:rPr lang="ko-KR" altLang="en-US" smtClean="0"/>
              <a:pPr/>
              <a:t>3/27/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705DF-C78A-4C15-9C16-BBE62339C2B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24807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72B03-8135-44CE-88F9-2CB997127D73}" type="datetimeFigureOut">
              <a:rPr lang="ko-KR" altLang="en-US" smtClean="0"/>
              <a:pPr/>
              <a:t>3/27/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705DF-C78A-4C15-9C16-BBE62339C2B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61871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72B03-8135-44CE-88F9-2CB997127D73}" type="datetimeFigureOut">
              <a:rPr lang="ko-KR" altLang="en-US" smtClean="0"/>
              <a:pPr/>
              <a:t>3/27/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705DF-C78A-4C15-9C16-BBE62339C2B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872121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72B03-8135-44CE-88F9-2CB997127D73}" type="datetimeFigureOut">
              <a:rPr lang="ko-KR" altLang="en-US" smtClean="0"/>
              <a:pPr/>
              <a:t>3/27/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705DF-C78A-4C15-9C16-BBE62339C2B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1385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72B03-8135-44CE-88F9-2CB997127D73}" type="datetimeFigureOut">
              <a:rPr lang="ko-KR" altLang="en-US" smtClean="0"/>
              <a:pPr/>
              <a:t>3/27/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705DF-C78A-4C15-9C16-BBE62339C2B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802315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72B03-8135-44CE-88F9-2CB997127D73}" type="datetimeFigureOut">
              <a:rPr lang="ko-KR" altLang="en-US" smtClean="0"/>
              <a:pPr/>
              <a:t>3/27/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705DF-C78A-4C15-9C16-BBE62339C2B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13514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72B03-8135-44CE-88F9-2CB997127D73}" type="datetimeFigureOut">
              <a:rPr lang="ko-KR" altLang="en-US" smtClean="0"/>
              <a:pPr/>
              <a:t>3/27/1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705DF-C78A-4C15-9C16-BBE62339C2B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161542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72B03-8135-44CE-88F9-2CB997127D73}" type="datetimeFigureOut">
              <a:rPr lang="ko-KR" altLang="en-US" smtClean="0"/>
              <a:pPr/>
              <a:t>3/27/1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705DF-C78A-4C15-9C16-BBE62339C2B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474541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72B03-8135-44CE-88F9-2CB997127D73}" type="datetimeFigureOut">
              <a:rPr lang="ko-KR" altLang="en-US" smtClean="0"/>
              <a:pPr/>
              <a:t>3/27/1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705DF-C78A-4C15-9C16-BBE62339C2B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344245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72B03-8135-44CE-88F9-2CB997127D73}" type="datetimeFigureOut">
              <a:rPr lang="ko-KR" altLang="en-US" smtClean="0"/>
              <a:pPr/>
              <a:t>3/27/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705DF-C78A-4C15-9C16-BBE62339C2B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603565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72B03-8135-44CE-88F9-2CB997127D73}" type="datetimeFigureOut">
              <a:rPr lang="ko-KR" altLang="en-US" smtClean="0"/>
              <a:pPr/>
              <a:t>3/27/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705DF-C78A-4C15-9C16-BBE62339C2B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39193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772B03-8135-44CE-88F9-2CB997127D73}" type="datetimeFigureOut">
              <a:rPr lang="ko-KR" altLang="en-US" smtClean="0"/>
              <a:pPr/>
              <a:t>3/27/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5705DF-C78A-4C15-9C16-BBE62339C2B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810053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4" Type="http://schemas.openxmlformats.org/officeDocument/2006/relationships/image" Target="../media/image6.jpeg"/><Relationship Id="rId5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96367" y="6094620"/>
            <a:ext cx="1078201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. Protein sequence alignment of the </a:t>
            </a:r>
            <a:r>
              <a:rPr lang="el-GR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gliadins identified in </a:t>
            </a:r>
            <a:r>
              <a:rPr lang="en-US" altLang="ko-KR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eumkang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gliadin extract fractions. </a:t>
            </a:r>
          </a:p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, spot with  </a:t>
            </a:r>
            <a:r>
              <a:rPr lang="el-GR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gliadin as a minor component; Yellow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background,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enome-specific motifs;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reen background, CSTT motif;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Red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ackground, epitopes for CD; Red letter, cysteine residues 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그룹 12"/>
          <p:cNvGrpSpPr/>
          <p:nvPr/>
        </p:nvGrpSpPr>
        <p:grpSpPr>
          <a:xfrm>
            <a:off x="1443782" y="0"/>
            <a:ext cx="9272820" cy="5998984"/>
            <a:chOff x="1443782" y="0"/>
            <a:chExt cx="9272820" cy="5998984"/>
          </a:xfrm>
        </p:grpSpPr>
        <p:sp>
          <p:nvSpPr>
            <p:cNvPr id="14" name="직사각형 13"/>
            <p:cNvSpPr/>
            <p:nvPr/>
          </p:nvSpPr>
          <p:spPr>
            <a:xfrm>
              <a:off x="9887578" y="3275763"/>
              <a:ext cx="180000" cy="241160"/>
            </a:xfrm>
            <a:prstGeom prst="rect">
              <a:avLst/>
            </a:prstGeom>
            <a:solidFill>
              <a:srgbClr val="00B050">
                <a:alpha val="5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5" name="직사각형 14"/>
            <p:cNvSpPr/>
            <p:nvPr/>
          </p:nvSpPr>
          <p:spPr>
            <a:xfrm>
              <a:off x="9887578" y="4834931"/>
              <a:ext cx="180000" cy="241160"/>
            </a:xfrm>
            <a:prstGeom prst="rect">
              <a:avLst/>
            </a:prstGeom>
            <a:solidFill>
              <a:srgbClr val="00B050">
                <a:alpha val="5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6" name="직사각형 15"/>
            <p:cNvSpPr/>
            <p:nvPr/>
          </p:nvSpPr>
          <p:spPr>
            <a:xfrm>
              <a:off x="9887578" y="4649035"/>
              <a:ext cx="180000" cy="61200"/>
            </a:xfrm>
            <a:prstGeom prst="rect">
              <a:avLst/>
            </a:prstGeom>
            <a:solidFill>
              <a:srgbClr val="00B050">
                <a:alpha val="5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7" name="직사각형 16"/>
            <p:cNvSpPr/>
            <p:nvPr/>
          </p:nvSpPr>
          <p:spPr>
            <a:xfrm>
              <a:off x="9887578" y="4283945"/>
              <a:ext cx="180000" cy="61200"/>
            </a:xfrm>
            <a:prstGeom prst="rect">
              <a:avLst/>
            </a:prstGeom>
            <a:solidFill>
              <a:srgbClr val="00B050">
                <a:alpha val="5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8" name="직사각형 17"/>
            <p:cNvSpPr/>
            <p:nvPr/>
          </p:nvSpPr>
          <p:spPr>
            <a:xfrm>
              <a:off x="9887578" y="4099725"/>
              <a:ext cx="180000" cy="61200"/>
            </a:xfrm>
            <a:prstGeom prst="rect">
              <a:avLst/>
            </a:prstGeom>
            <a:solidFill>
              <a:srgbClr val="00B050">
                <a:alpha val="5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9" name="직사각형 18"/>
            <p:cNvSpPr/>
            <p:nvPr/>
          </p:nvSpPr>
          <p:spPr>
            <a:xfrm>
              <a:off x="9887578" y="3732958"/>
              <a:ext cx="180000" cy="61200"/>
            </a:xfrm>
            <a:prstGeom prst="rect">
              <a:avLst/>
            </a:prstGeom>
            <a:solidFill>
              <a:srgbClr val="00B050">
                <a:alpha val="5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pic>
          <p:nvPicPr>
            <p:cNvPr id="20" name="그림 19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43782" y="0"/>
              <a:ext cx="9272820" cy="5998984"/>
            </a:xfrm>
            <a:prstGeom prst="rect">
              <a:avLst/>
            </a:prstGeom>
          </p:spPr>
        </p:pic>
        <p:sp>
          <p:nvSpPr>
            <p:cNvPr id="21" name="TextBox 20"/>
            <p:cNvSpPr txBox="1"/>
            <p:nvPr/>
          </p:nvSpPr>
          <p:spPr>
            <a:xfrm>
              <a:off x="9790081" y="3121082"/>
              <a:ext cx="38504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STT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8809600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610403" y="6158449"/>
            <a:ext cx="109676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2. Protein sequence alignment of the </a:t>
            </a:r>
            <a:r>
              <a:rPr lang="el-GR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gliadins identified in </a:t>
            </a:r>
            <a:r>
              <a:rPr lang="en-US" altLang="ko-KR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eumkang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gliadin extract fractions. </a:t>
            </a:r>
          </a:p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*, spot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l-GR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gliadin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as a minor component; Orange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ackground, epitopes for CD; Red letter, cysteine residues 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80409" y="188728"/>
            <a:ext cx="9627638" cy="59697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775524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029075" y="4680032"/>
            <a:ext cx="1028041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3. Protein sequence alignment of the </a:t>
            </a:r>
            <a:r>
              <a:rPr lang="el-GR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ω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-gliadins identified in gliadin fractions from cv. </a:t>
            </a:r>
            <a:r>
              <a:rPr lang="en-US" altLang="ko-KR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eumkang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lour.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 indicates spot with </a:t>
            </a:r>
            <a:r>
              <a:rPr lang="el-GR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ω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gliadin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as a minor component.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he epitopes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for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WDEIA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l-GR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ω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-gliadin are marked such as QQIPQQQ (Yellow background), QQFPQQQ (Red background), QQSPEQQQ (Blue box) and QQSPQQQ (Black box). 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그림 10"/>
          <p:cNvPicPr>
            <a:picLocks noChangeAspect="1"/>
          </p:cNvPicPr>
          <p:nvPr/>
        </p:nvPicPr>
        <p:blipFill rotWithShape="1">
          <a:blip r:embed="rId2"/>
          <a:srcRect l="5081"/>
          <a:stretch/>
        </p:blipFill>
        <p:spPr>
          <a:xfrm>
            <a:off x="1271452" y="441844"/>
            <a:ext cx="8848135" cy="35728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4131823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198070" y="5158078"/>
            <a:ext cx="1028041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4. Protein sequence alignment of the </a:t>
            </a:r>
            <a:r>
              <a:rPr lang="el-GR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ω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,2-gliadins identified in gliadin fractions from cv. </a:t>
            </a:r>
            <a:r>
              <a:rPr lang="en-US" altLang="ko-KR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eumkang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lour.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D-relevant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epitopes in </a:t>
            </a:r>
            <a:r>
              <a:rPr lang="el-GR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ω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1,2-gliadin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nclude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DQ2.5-glia-</a:t>
            </a:r>
            <a:r>
              <a:rPr lang="el-GR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ω1 (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FPQPQQPF, Black box),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DQ2.5-glia-</a:t>
            </a:r>
            <a:r>
              <a:rPr lang="el-GR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ω2 (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QPQQPFPW, Red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background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),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DQ2.5-glia-</a:t>
            </a:r>
            <a:r>
              <a:rPr lang="el-GR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γ4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c/DQ8-glia-</a:t>
            </a:r>
            <a:r>
              <a:rPr lang="el-GR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γ1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a (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QQPQQPFPQ,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Yellow background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DQ2.5-glia-</a:t>
            </a:r>
            <a:r>
              <a:rPr lang="el-GR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γ5 (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QQPFPQQPQ,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Blue box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2"/>
          <a:srcRect l="3904" r="11414"/>
          <a:stretch/>
        </p:blipFill>
        <p:spPr>
          <a:xfrm>
            <a:off x="1585607" y="332614"/>
            <a:ext cx="9291332" cy="46382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380778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9" name="그룹 248"/>
          <p:cNvGrpSpPr/>
          <p:nvPr/>
        </p:nvGrpSpPr>
        <p:grpSpPr>
          <a:xfrm>
            <a:off x="948835" y="1436912"/>
            <a:ext cx="9704173" cy="3378500"/>
            <a:chOff x="948835" y="1436912"/>
            <a:chExt cx="9704173" cy="3378500"/>
          </a:xfrm>
        </p:grpSpPr>
        <p:pic>
          <p:nvPicPr>
            <p:cNvPr id="242" name="그림 24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48835" y="1575412"/>
              <a:ext cx="3560440" cy="3240000"/>
            </a:xfrm>
            <a:prstGeom prst="rect">
              <a:avLst/>
            </a:prstGeom>
          </p:spPr>
        </p:pic>
        <p:pic>
          <p:nvPicPr>
            <p:cNvPr id="243" name="그림 242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571"/>
            <a:stretch/>
          </p:blipFill>
          <p:spPr>
            <a:xfrm>
              <a:off x="4708287" y="1755411"/>
              <a:ext cx="2864750" cy="28800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</p:pic>
        <p:pic>
          <p:nvPicPr>
            <p:cNvPr id="244" name="그림 243"/>
            <p:cNvPicPr>
              <a:picLocks noChangeAspect="1"/>
            </p:cNvPicPr>
            <p:nvPr/>
          </p:nvPicPr>
          <p:blipFill rotWithShape="1">
            <a:blip r:embed="rId5"/>
            <a:srcRect t="1" b="2017"/>
            <a:stretch/>
          </p:blipFill>
          <p:spPr>
            <a:xfrm>
              <a:off x="7746929" y="1755412"/>
              <a:ext cx="2906079" cy="288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45" name="TextBox 244"/>
            <p:cNvSpPr txBox="1"/>
            <p:nvPr/>
          </p:nvSpPr>
          <p:spPr>
            <a:xfrm>
              <a:off x="1335684" y="1436912"/>
              <a:ext cx="4058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st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" name="TextBox 245"/>
            <p:cNvSpPr txBox="1"/>
            <p:nvPr/>
          </p:nvSpPr>
          <p:spPr>
            <a:xfrm>
              <a:off x="4771215" y="1436912"/>
              <a:ext cx="4587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nd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7" name="TextBox 246"/>
            <p:cNvSpPr txBox="1"/>
            <p:nvPr/>
          </p:nvSpPr>
          <p:spPr>
            <a:xfrm>
              <a:off x="7877558" y="1436912"/>
              <a:ext cx="4235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rd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48" name="TextBox 247"/>
          <p:cNvSpPr txBox="1"/>
          <p:nvPr/>
        </p:nvSpPr>
        <p:spPr>
          <a:xfrm>
            <a:off x="2435417" y="5023466"/>
            <a:ext cx="673100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5. 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-DE of 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liadin 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proteins in </a:t>
            </a:r>
            <a:r>
              <a:rPr lang="en-US" altLang="ko-K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Keumkang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lour. </a:t>
            </a:r>
          </a:p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liadin proteins were three times extracted in different biological samples and then each extract was separated in 2-DE using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trips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altLang="ko-KR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I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6-11.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39431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65417" y="532102"/>
            <a:ext cx="5103524" cy="469166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709085" y="5371810"/>
            <a:ext cx="704864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6. 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-DE of </a:t>
            </a:r>
            <a:r>
              <a:rPr lang="en-US" altLang="ko-KR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liadin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proteins in </a:t>
            </a:r>
            <a:r>
              <a:rPr lang="en-US" altLang="ko-K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Keumkang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lour. </a:t>
            </a:r>
          </a:p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liadin proteins were extracted and separated in 2-DE using strip of </a:t>
            </a:r>
            <a:r>
              <a:rPr lang="en-US" altLang="ko-KR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I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3-11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1400" dirty="0" smtClean="0">
                <a:latin typeface="Symbol" charset="2"/>
                <a:cs typeface="Symbol" charset="2"/>
              </a:rPr>
              <a:t>w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ko-KR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liadins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are shown in boxes.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919923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72</TotalTime>
  <Words>342</Words>
  <Application>Microsoft Macintosh PowerPoint</Application>
  <PresentationFormat>Custom</PresentationFormat>
  <Paragraphs>15</Paragraphs>
  <Slides>6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테마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Cho-KW</dc:creator>
  <cp:lastModifiedBy>Susan Altenbach</cp:lastModifiedBy>
  <cp:revision>86</cp:revision>
  <dcterms:created xsi:type="dcterms:W3CDTF">2017-06-08T06:29:35Z</dcterms:created>
  <dcterms:modified xsi:type="dcterms:W3CDTF">2018-03-28T00:27:48Z</dcterms:modified>
</cp:coreProperties>
</file>